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74F858-5E8D-41ED-9532-65C8D600C2D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9109A6-B8A5-4606-A15D-9C4FDA7A55E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306520" y="720720"/>
            <a:ext cx="2702160" cy="360036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19FEBF-0F9C-4644-AAF9-8B9240A31A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995FF-CA95-4A6E-8344-92FA2208AA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DE6B4-7052-4C57-AA84-41CE996B64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71B09-97A8-4210-97D5-3ECB568BA7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005C0-05A2-416B-AB12-A4FAF087B5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27F92-0C17-49F8-A545-66D89B61FC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44D96-BD6C-405F-ACB7-3A479A029C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420EA-2736-4F3A-8350-1CB6E13796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9D2A5-84DC-4FA8-9911-215CF90324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F44AE-1928-4BE9-9133-6DDF79F1BF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236A9-3EC7-4342-A68A-1B9E649031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8AFD1-026E-4608-9A87-56EE716C37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7B3214-311E-45B3-9CC1-DEBBDFD64B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rcRect l="0" t="7692" r="0" b="0"/>
          <a:stretch/>
        </p:blipFill>
        <p:spPr>
          <a:xfrm>
            <a:off x="609480" y="351000"/>
            <a:ext cx="5639040" cy="22557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"/>
          <p:cNvPicPr/>
          <p:nvPr/>
        </p:nvPicPr>
        <p:blipFill>
          <a:blip r:embed="rId2"/>
          <a:srcRect l="0" t="7692" r="0" b="0"/>
          <a:stretch/>
        </p:blipFill>
        <p:spPr>
          <a:xfrm>
            <a:off x="609480" y="2743200"/>
            <a:ext cx="5639040" cy="22557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3"/>
          <a:srcRect l="0" t="7403" r="0" b="0"/>
          <a:stretch/>
        </p:blipFill>
        <p:spPr>
          <a:xfrm>
            <a:off x="609480" y="5116680"/>
            <a:ext cx="5639040" cy="2350800"/>
          </a:xfrm>
          <a:prstGeom prst="rect">
            <a:avLst/>
          </a:prstGeom>
          <a:ln w="0">
            <a:noFill/>
          </a:ln>
        </p:spPr>
      </p:pic>
      <p:sp>
        <p:nvSpPr>
          <p:cNvPr id="51" name="Text Box 6"/>
          <p:cNvSpPr/>
          <p:nvPr/>
        </p:nvSpPr>
        <p:spPr>
          <a:xfrm>
            <a:off x="481680" y="2544840"/>
            <a:ext cx="347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.  Chromosomal distribution of crosshyb prob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9"/>
          <p:cNvSpPr/>
          <p:nvPr/>
        </p:nvSpPr>
        <p:spPr>
          <a:xfrm>
            <a:off x="526320" y="152280"/>
            <a:ext cx="356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.  Chromosomal distribution of multi-copy prob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0"/>
          <p:cNvSpPr/>
          <p:nvPr/>
        </p:nvSpPr>
        <p:spPr>
          <a:xfrm>
            <a:off x="524160" y="4906800"/>
            <a:ext cx="37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.  Chromosomal distribution of cereal repeat prob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2"/>
          <p:cNvSpPr/>
          <p:nvPr/>
        </p:nvSpPr>
        <p:spPr>
          <a:xfrm>
            <a:off x="5641920" y="4632480"/>
            <a:ext cx="457200" cy="75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1"/>
          <p:cNvSpPr/>
          <p:nvPr/>
        </p:nvSpPr>
        <p:spPr>
          <a:xfrm>
            <a:off x="5518080" y="4578480"/>
            <a:ext cx="660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rosshyb probe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4"/>
          <p:cNvSpPr/>
          <p:nvPr/>
        </p:nvSpPr>
        <p:spPr>
          <a:xfrm>
            <a:off x="5749920" y="7086600"/>
            <a:ext cx="328680" cy="7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5"/>
          <p:cNvSpPr/>
          <p:nvPr/>
        </p:nvSpPr>
        <p:spPr>
          <a:xfrm>
            <a:off x="5607360" y="7032600"/>
            <a:ext cx="578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ereal probe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6"/>
          <p:cNvSpPr/>
          <p:nvPr/>
        </p:nvSpPr>
        <p:spPr>
          <a:xfrm>
            <a:off x="5746680" y="2241720"/>
            <a:ext cx="328680" cy="75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7"/>
          <p:cNvSpPr/>
          <p:nvPr/>
        </p:nvSpPr>
        <p:spPr>
          <a:xfrm>
            <a:off x="5607000" y="2187720"/>
            <a:ext cx="5266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ulti probe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19:06Z</dcterms:modified>
  <cp:revision>28</cp:revision>
  <dc:subject/>
  <dc:title>Slide 1</dc:title>
</cp:coreProperties>
</file>